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44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F52D999-4C66-433C-B02B-F796B0C4D77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D10298EC-F9E7-4DAB-BE1D-981C4A1D769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EBFB6E4-BA6E-45FE-8B46-255AB73047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90A64-E4BF-4C1C-8000-9C042ECB50EC}" type="datetimeFigureOut">
              <a:rPr lang="it-IT" smtClean="0"/>
              <a:t>01/08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396FA42-4A90-4DFB-8114-F76665A914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873D209-EEC7-469C-972A-7016862749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0D4FB-08FB-454A-85DC-3583DB36637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775832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2297153-34D3-4852-9D83-1F615F7475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323B5E65-3A6D-46CF-B7E7-DCBA539981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26A3E97-0E47-40B2-8020-DEC917C417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90A64-E4BF-4C1C-8000-9C042ECB50EC}" type="datetimeFigureOut">
              <a:rPr lang="it-IT" smtClean="0"/>
              <a:t>01/08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0FE7A29-3765-4E58-95CC-1894EC9E33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3AE79EF-9981-42E0-9B88-7FDDF93000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0D4FB-08FB-454A-85DC-3583DB36637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515899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55A81298-F822-435C-A8D2-86D6595C655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89D22F8C-CE44-4490-9396-05F21B164F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E1073A8-C417-44B4-A763-51708ABC16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90A64-E4BF-4C1C-8000-9C042ECB50EC}" type="datetimeFigureOut">
              <a:rPr lang="it-IT" smtClean="0"/>
              <a:t>01/08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609EA7D-5B29-4E4F-AFD0-2CCEED58BC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EE917F3-0C9E-4F92-978F-1C1AF9F375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0D4FB-08FB-454A-85DC-3583DB36637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652646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5C5D8C9-420C-4EDA-957F-0821022249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DFA7DDC-6E35-4C89-AAD6-C7FCD4E139B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76615CB-678D-479E-9B35-1C777FE90A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90A64-E4BF-4C1C-8000-9C042ECB50EC}" type="datetimeFigureOut">
              <a:rPr lang="it-IT" smtClean="0"/>
              <a:t>01/08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0E54AE5-2CA1-4862-B516-42A43759BE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2B1D88F-EE92-429B-8211-2F0065C75D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0D4FB-08FB-454A-85DC-3583DB36637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248574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7F340FF-B206-453A-99D9-E0565275E5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0190F16-C578-4EA6-8F8E-6691FA155B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1AF6E81-5C54-4184-90CA-E452591224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90A64-E4BF-4C1C-8000-9C042ECB50EC}" type="datetimeFigureOut">
              <a:rPr lang="it-IT" smtClean="0"/>
              <a:t>01/08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F72A937-77BE-4C1F-99F5-1B35A8A097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C94FC60-1A00-4C59-9C2E-464C4025C3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0D4FB-08FB-454A-85DC-3583DB36637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834804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C3F3284-8B3E-4D01-A5C7-DBE9C6C033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E8BD3180-E0C8-4376-ACAF-66BE2DA570D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456AD891-9315-453C-90F7-3C96D79C76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F0EC116-BD8E-41DB-952F-3A136620B0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90A64-E4BF-4C1C-8000-9C042ECB50EC}" type="datetimeFigureOut">
              <a:rPr lang="it-IT" smtClean="0"/>
              <a:t>01/08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60E89EFE-625E-4421-899D-73D061FB67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8DEFBC6-BB25-4369-B24B-0722F3A2AF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0D4FB-08FB-454A-85DC-3583DB36637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143552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00EB8A9-C710-4569-8B8E-73F5931CBB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0B300A3-A5F0-4202-A2FD-001C133552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E0AD61DA-0EF0-400B-8DAC-F540C895C9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D00F2CDA-8EE2-46CA-9F16-4F229B7E314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568A448B-7949-451D-B03F-6DC19D545C1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FC7B37AC-9AF2-4EDF-BF3D-7BED6ACCF4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90A64-E4BF-4C1C-8000-9C042ECB50EC}" type="datetimeFigureOut">
              <a:rPr lang="it-IT" smtClean="0"/>
              <a:t>01/08/20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A1FD93B1-C0EC-4D5C-92FE-5750259365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C0561795-5825-48CB-B5D3-461E6919DB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0D4FB-08FB-454A-85DC-3583DB36637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148701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32B3F90-10B5-4C0F-B50B-D018D6F081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99A2E6EA-70FB-4CFA-89F5-FA33127F12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90A64-E4BF-4C1C-8000-9C042ECB50EC}" type="datetimeFigureOut">
              <a:rPr lang="it-IT" smtClean="0"/>
              <a:t>01/08/20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66596CBC-2BA1-47BA-B813-B1B13BDEE6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3B809308-8C33-4315-99C5-559BD1D452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0D4FB-08FB-454A-85DC-3583DB36637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849237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B8039DC4-C61A-498D-BB3C-42F1A255A5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90A64-E4BF-4C1C-8000-9C042ECB50EC}" type="datetimeFigureOut">
              <a:rPr lang="it-IT" smtClean="0"/>
              <a:t>01/08/20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119EB0F7-6248-4B32-B8EF-AC94F88CB5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3FCF12BB-20EF-43BC-A64B-20FE97B3BA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0D4FB-08FB-454A-85DC-3583DB36637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79956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1AEA971-6472-473B-B782-022A2D9861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66F5DAD-734D-4112-ABB1-983AE8E7231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0A37DCBE-F0C9-48C3-A31E-F88C00DAA2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2620181-921C-4B01-85A5-79BA735E1B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90A64-E4BF-4C1C-8000-9C042ECB50EC}" type="datetimeFigureOut">
              <a:rPr lang="it-IT" smtClean="0"/>
              <a:t>01/08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5FD3B96-C809-4731-BC2F-E4DF077CEF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63A3D23-3CF8-48A6-AA6E-3815B95D3B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0D4FB-08FB-454A-85DC-3583DB36637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013494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5B2E689-901F-480D-8DD4-0D0BECE7FF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B4F57AAA-1E51-4AB1-A66B-0BD7956A46D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3605736-198C-4AC3-B538-14EB795771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B9FEB80-0686-4925-B805-41CEEB4DAF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90A64-E4BF-4C1C-8000-9C042ECB50EC}" type="datetimeFigureOut">
              <a:rPr lang="it-IT" smtClean="0"/>
              <a:t>01/08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FE32C9F7-06F9-4A07-9F43-2511667C11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D536DDE-257A-40AE-9EFA-4AA201178D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0D4FB-08FB-454A-85DC-3583DB36637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007730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1F0EFC7E-13D5-4B40-A02A-CDDB027DA7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9F164B41-0399-4B48-9D2E-1321A902B8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D7B13CC-4E05-4BD3-8298-DAE8736F9D0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E90A64-E4BF-4C1C-8000-9C042ECB50EC}" type="datetimeFigureOut">
              <a:rPr lang="it-IT" smtClean="0"/>
              <a:t>01/08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93F78D8-48DD-471D-A5C2-FB1E13E7206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7F394EF-A9EB-4FEE-884E-D09F0973BCA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A0D4FB-08FB-454A-85DC-3583DB36637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63868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4256F73E-D1B7-49E6-B46A-C5879DFB35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55493" y="846548"/>
            <a:ext cx="2601666" cy="1928110"/>
          </a:xfrm>
          <a:prstGeom prst="rect">
            <a:avLst/>
          </a:prstGeom>
          <a:ln>
            <a:noFill/>
          </a:ln>
        </p:spPr>
      </p:pic>
      <p:pic>
        <p:nvPicPr>
          <p:cNvPr id="6" name="Immagine 5">
            <a:extLst>
              <a:ext uri="{FF2B5EF4-FFF2-40B4-BE49-F238E27FC236}">
                <a16:creationId xmlns:a16="http://schemas.microsoft.com/office/drawing/2014/main" id="{23BC7CB3-187F-4D68-A688-E66D4BCB74C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2" t="16012" r="819" b="3256"/>
          <a:stretch/>
        </p:blipFill>
        <p:spPr>
          <a:xfrm>
            <a:off x="993448" y="3191117"/>
            <a:ext cx="5388753" cy="2208944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A4984557-4DED-479A-AEFD-F4EF12C50C40}"/>
              </a:ext>
            </a:extLst>
          </p:cNvPr>
          <p:cNvSpPr txBox="1"/>
          <p:nvPr/>
        </p:nvSpPr>
        <p:spPr>
          <a:xfrm>
            <a:off x="711959" y="708048"/>
            <a:ext cx="4255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/>
              <a:t>a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444958D0-6FD5-456A-A479-49FEAA240918}"/>
              </a:ext>
            </a:extLst>
          </p:cNvPr>
          <p:cNvSpPr txBox="1"/>
          <p:nvPr/>
        </p:nvSpPr>
        <p:spPr>
          <a:xfrm>
            <a:off x="711959" y="3052617"/>
            <a:ext cx="4255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/>
              <a:t>b</a:t>
            </a:r>
          </a:p>
        </p:txBody>
      </p:sp>
      <p:sp>
        <p:nvSpPr>
          <p:cNvPr id="3" name="Rettangolo 2">
            <a:extLst>
              <a:ext uri="{FF2B5EF4-FFF2-40B4-BE49-F238E27FC236}">
                <a16:creationId xmlns:a16="http://schemas.microsoft.com/office/drawing/2014/main" id="{AA8E5367-1558-4703-B810-D590AF1FAA06}"/>
              </a:ext>
            </a:extLst>
          </p:cNvPr>
          <p:cNvSpPr/>
          <p:nvPr/>
        </p:nvSpPr>
        <p:spPr>
          <a:xfrm>
            <a:off x="808491" y="5577602"/>
            <a:ext cx="6096000" cy="694357"/>
          </a:xfrm>
          <a:prstGeom prst="rect">
            <a:avLst/>
          </a:prstGeom>
        </p:spPr>
        <p:txBody>
          <a:bodyPr>
            <a:spAutoFit/>
          </a:bodyPr>
          <a:lstStyle/>
          <a:p>
            <a:pPr marL="228600">
              <a:lnSpc>
                <a:spcPct val="150000"/>
              </a:lnSpc>
              <a:spcAft>
                <a:spcPts val="800"/>
              </a:spcAft>
            </a:pPr>
            <a:r>
              <a:rPr lang="en-GB" sz="900" b="1">
                <a:latin typeface="Palatino Linotype" panose="0204050205050503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Figure S2</a:t>
            </a:r>
            <a:r>
              <a:rPr lang="en-GB" sz="900">
                <a:latin typeface="Palatino Linotype" panose="0204050205050503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. (</a:t>
            </a:r>
            <a:r>
              <a:rPr lang="en-GB" sz="900" b="1">
                <a:latin typeface="Palatino Linotype" panose="0204050205050503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GB" sz="900">
                <a:latin typeface="Palatino Linotype" panose="0204050205050503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) Putative structure of propionylcarnitine glycine conjugate; (</a:t>
            </a:r>
            <a:r>
              <a:rPr lang="en-GB" sz="900" b="1">
                <a:latin typeface="Palatino Linotype" panose="0204050205050503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en-GB" sz="900">
                <a:latin typeface="Palatino Linotype" panose="0204050205050503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) Comparison between </a:t>
            </a:r>
            <a:r>
              <a:rPr lang="en-GB" sz="900" i="1">
                <a:latin typeface="Palatino Linotype" panose="0204050205050503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in-silico</a:t>
            </a:r>
            <a:r>
              <a:rPr lang="en-GB" sz="900">
                <a:latin typeface="Palatino Linotype" panose="0204050205050503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 predicted MS/MS fragmentations of the putative structure and real MS/MS spectrum. The matching hits are green coloured. </a:t>
            </a:r>
            <a:endParaRPr lang="it-IT" sz="900">
              <a:effectLst/>
              <a:latin typeface="Palatino Linotype" panose="02040502050505030304" pitchFamily="18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6932317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4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atesini Giulio</dc:creator>
  <cp:lastModifiedBy>Catesini Giulio</cp:lastModifiedBy>
  <cp:revision>4</cp:revision>
  <dcterms:created xsi:type="dcterms:W3CDTF">2024-03-06T12:55:21Z</dcterms:created>
  <dcterms:modified xsi:type="dcterms:W3CDTF">2024-08-01T07:55:20Z</dcterms:modified>
</cp:coreProperties>
</file>